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6" r:id="rId2"/>
    <p:sldId id="257" r:id="rId3"/>
    <p:sldId id="262" r:id="rId4"/>
    <p:sldId id="263" r:id="rId5"/>
    <p:sldId id="264" r:id="rId6"/>
    <p:sldId id="265" r:id="rId7"/>
  </p:sldIdLst>
  <p:sldSz cx="12192000" cy="6858000"/>
  <p:notesSz cx="6858000" cy="9144000"/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u Guanhua" initials="LG" lastIdx="8" clrIdx="0">
    <p:extLst>
      <p:ext uri="{19B8F6BF-5375-455C-9EA6-DF929625EA0E}">
        <p15:presenceInfo xmlns:p15="http://schemas.microsoft.com/office/powerpoint/2012/main" userId="9b939cd4fcf97172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3885" autoAdjust="0"/>
  </p:normalViewPr>
  <p:slideViewPr>
    <p:cSldViewPr snapToGrid="0">
      <p:cViewPr>
        <p:scale>
          <a:sx n="70" d="100"/>
          <a:sy n="70" d="100"/>
        </p:scale>
        <p:origin x="1066" y="21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>
            <a:extLst>
              <a:ext uri="{FF2B5EF4-FFF2-40B4-BE49-F238E27FC236}">
                <a16:creationId xmlns:a16="http://schemas.microsoft.com/office/drawing/2014/main" id="{C352D43A-9D0B-4C27-8056-F6E6154D5BD6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FFD613B-05F8-4759-A7B5-D9887D6CB7BB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6E6104AA-28FD-4900-9A76-D99FA22EAF48}" type="datetimeFigureOut">
              <a:rPr lang="zh-CN" altLang="en-US"/>
              <a:pPr>
                <a:defRPr/>
              </a:pPr>
              <a:t>2018/12/8</a:t>
            </a:fld>
            <a:endParaRPr lang="zh-CN" altLang="en-US"/>
          </a:p>
        </p:txBody>
      </p:sp>
      <p:sp>
        <p:nvSpPr>
          <p:cNvPr id="4" name="幻灯片图像占位符 3">
            <a:extLst>
              <a:ext uri="{FF2B5EF4-FFF2-40B4-BE49-F238E27FC236}">
                <a16:creationId xmlns:a16="http://schemas.microsoft.com/office/drawing/2014/main" id="{62246C72-E866-42B2-B7A4-BDCB286FB5C6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备注占位符 4">
            <a:extLst>
              <a:ext uri="{FF2B5EF4-FFF2-40B4-BE49-F238E27FC236}">
                <a16:creationId xmlns:a16="http://schemas.microsoft.com/office/drawing/2014/main" id="{8601957D-F6F4-4953-8B4D-789DBAE267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noProof="0"/>
              <a:t>单击此处编辑母版文本样式</a:t>
            </a:r>
          </a:p>
          <a:p>
            <a:pPr lvl="1"/>
            <a:r>
              <a:rPr lang="zh-CN" altLang="en-US" noProof="0"/>
              <a:t>第二级</a:t>
            </a:r>
          </a:p>
          <a:p>
            <a:pPr lvl="2"/>
            <a:r>
              <a:rPr lang="zh-CN" altLang="en-US" noProof="0"/>
              <a:t>第三级</a:t>
            </a:r>
          </a:p>
          <a:p>
            <a:pPr lvl="3"/>
            <a:r>
              <a:rPr lang="zh-CN" altLang="en-US" noProof="0"/>
              <a:t>第四级</a:t>
            </a:r>
          </a:p>
          <a:p>
            <a:pPr lvl="4"/>
            <a:r>
              <a:rPr lang="zh-CN" altLang="en-US" noProof="0"/>
              <a:t>第五级</a:t>
            </a:r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290716A-AE9C-413D-99F1-361E36780CC9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FD31908-F6C6-4F28-BAE9-1E3002255E9D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F9B91954-CEE5-48A2-9874-4FEE000A3290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841753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幻灯片图像占位符 1">
            <a:extLst>
              <a:ext uri="{FF2B5EF4-FFF2-40B4-BE49-F238E27FC236}">
                <a16:creationId xmlns:a16="http://schemas.microsoft.com/office/drawing/2014/main" id="{20F7940D-9EB4-4A21-9FAF-DFDFABDF114F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0243" name="备注占位符 2">
            <a:extLst>
              <a:ext uri="{FF2B5EF4-FFF2-40B4-BE49-F238E27FC236}">
                <a16:creationId xmlns:a16="http://schemas.microsoft.com/office/drawing/2014/main" id="{16CBF601-C207-4702-9AD5-848AF72BEF03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0244" name="灯片编号占位符 3">
            <a:extLst>
              <a:ext uri="{FF2B5EF4-FFF2-40B4-BE49-F238E27FC236}">
                <a16:creationId xmlns:a16="http://schemas.microsoft.com/office/drawing/2014/main" id="{59A09167-DCA7-49F5-A0AE-244D9D0722E6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fld id="{90B2BA75-750F-41B9-B28B-E5A2DE4189CF}" type="slidenum">
              <a:rPr lang="zh-CN" altLang="en-US" smtClean="0">
                <a:latin typeface="Calibri" panose="020F0502020204030204" pitchFamily="34" charset="0"/>
              </a:rPr>
              <a:pPr/>
              <a:t>2</a:t>
            </a:fld>
            <a:endParaRPr lang="zh-CN" altLang="en-US"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991873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幻灯片图像占位符 1">
            <a:extLst>
              <a:ext uri="{FF2B5EF4-FFF2-40B4-BE49-F238E27FC236}">
                <a16:creationId xmlns:a16="http://schemas.microsoft.com/office/drawing/2014/main" id="{51D6AE59-B71F-42DE-B15A-0A317F8488B4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2291" name="备注占位符 2">
            <a:extLst>
              <a:ext uri="{FF2B5EF4-FFF2-40B4-BE49-F238E27FC236}">
                <a16:creationId xmlns:a16="http://schemas.microsoft.com/office/drawing/2014/main" id="{7ED320CD-23FF-4321-BD8C-1DA90EEE56C2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/>
            <a:endParaRPr lang="zh-CN" altLang="en-US"/>
          </a:p>
        </p:txBody>
      </p:sp>
      <p:sp>
        <p:nvSpPr>
          <p:cNvPr id="12292" name="灯片编号占位符 3">
            <a:extLst>
              <a:ext uri="{FF2B5EF4-FFF2-40B4-BE49-F238E27FC236}">
                <a16:creationId xmlns:a16="http://schemas.microsoft.com/office/drawing/2014/main" id="{D1D7A595-B84D-4AAC-8B93-928DEE644477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</a:pPr>
            <a:fld id="{8F20778D-9FB7-4F8D-9B3F-2F77B73C2EFD}" type="slidenum">
              <a:rPr lang="zh-CN" altLang="en-US" smtClean="0"/>
              <a:pPr>
                <a:spcBef>
                  <a:spcPct val="0"/>
                </a:spcBef>
              </a:pPr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50855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幻灯片图像占位符 1">
            <a:extLst>
              <a:ext uri="{FF2B5EF4-FFF2-40B4-BE49-F238E27FC236}">
                <a16:creationId xmlns:a16="http://schemas.microsoft.com/office/drawing/2014/main" id="{8E3CDC97-FA22-4ED9-9C26-C487FFB9F4FC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5363" name="备注占位符 2">
            <a:extLst>
              <a:ext uri="{FF2B5EF4-FFF2-40B4-BE49-F238E27FC236}">
                <a16:creationId xmlns:a16="http://schemas.microsoft.com/office/drawing/2014/main" id="{3540A8EC-5BD4-4BCD-A1A5-D9B7FFBBCC27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5364" name="灯片编号占位符 3">
            <a:extLst>
              <a:ext uri="{FF2B5EF4-FFF2-40B4-BE49-F238E27FC236}">
                <a16:creationId xmlns:a16="http://schemas.microsoft.com/office/drawing/2014/main" id="{6E4D15C7-769D-4E4F-9B30-A9CAADBB2622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fld id="{1DFEA8D1-AD37-4F12-86F5-6008DD5E7E4F}" type="slidenum">
              <a:rPr lang="zh-CN" altLang="en-US" smtClean="0">
                <a:latin typeface="Calibri" panose="020F0502020204030204" pitchFamily="34" charset="0"/>
              </a:rPr>
              <a:pPr/>
              <a:t>5</a:t>
            </a:fld>
            <a:endParaRPr lang="zh-CN" altLang="en-US"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94901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0B3F358-D027-43E1-BA5C-52ED07BBC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834DF3-30A2-4FCC-8163-E597A41B74F0}" type="datetimeFigureOut">
              <a:rPr lang="zh-CN" altLang="en-US"/>
              <a:pPr>
                <a:defRPr/>
              </a:pPr>
              <a:t>2018/12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38DA19A-E469-4A24-8138-0CD77ECB0D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72612A0-9F37-4027-BD10-86C0B81408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408D93-6CF7-4CEB-8E3C-D12A3DF1A1B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04658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1AB28BD-71BF-47A1-84EE-B595C2A45D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D7E22E-9038-4B08-B1FD-B6604A332C51}" type="datetimeFigureOut">
              <a:rPr lang="zh-CN" altLang="en-US"/>
              <a:pPr>
                <a:defRPr/>
              </a:pPr>
              <a:t>2018/12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8FA0E10-0EE6-446B-85BB-DF3F15A149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DF21F23-3AAE-4D8A-812D-18D87B57D1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4DC2CA-7EDE-49BF-AC7A-C91C53F7E06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40955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2B09124-3728-449E-B6A4-CAAB719643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94C6F8-E62A-42DC-A4C2-B96D0059C735}" type="datetimeFigureOut">
              <a:rPr lang="zh-CN" altLang="en-US"/>
              <a:pPr>
                <a:defRPr/>
              </a:pPr>
              <a:t>2018/12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107E02D-2AA9-4B1E-A336-498FB44006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99F945C-DC85-4C8E-BA27-384CF74662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5DD87C-0D86-429E-89B4-9AE0C6B73EFA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2572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E5812C-87DB-44F4-A1EF-663C9510CA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A6A15F-E5D7-47CB-9313-CF90B4F1C0B9}" type="datetimeFigureOut">
              <a:rPr lang="zh-CN" altLang="en-US"/>
              <a:pPr>
                <a:defRPr/>
              </a:pPr>
              <a:t>2018/12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F2FF8FE-D2BE-4D9A-8E6A-894C42C73A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1119DF9-4790-4D2F-95D5-B43A728A32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4ABE3D-AAB0-46E3-BADB-67B66BE26B95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5554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44A57C9-C92B-4664-BAEC-6B51CDFA6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0F2F53-BC37-43D1-B8F3-0ECDF011B0AE}" type="datetimeFigureOut">
              <a:rPr lang="zh-CN" altLang="en-US"/>
              <a:pPr>
                <a:defRPr/>
              </a:pPr>
              <a:t>2018/12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E32655F-2F93-4BDF-9314-0EAFF57AB2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A3A2CC0-83B8-4701-BB7A-9B4D5D55D0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426030-EE83-4F31-8511-EE8754002A3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35346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3">
            <a:extLst>
              <a:ext uri="{FF2B5EF4-FFF2-40B4-BE49-F238E27FC236}">
                <a16:creationId xmlns:a16="http://schemas.microsoft.com/office/drawing/2014/main" id="{134B2AA1-C4D1-4AA4-8DFD-FE3F0762F1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0018E2-8F2C-4A66-AB4D-873C72A4E93C}" type="datetimeFigureOut">
              <a:rPr lang="zh-CN" altLang="en-US"/>
              <a:pPr>
                <a:defRPr/>
              </a:pPr>
              <a:t>2018/12/8</a:t>
            </a:fld>
            <a:endParaRPr lang="zh-CN" altLang="en-US"/>
          </a:p>
        </p:txBody>
      </p:sp>
      <p:sp>
        <p:nvSpPr>
          <p:cNvPr id="6" name="页脚占位符 4">
            <a:extLst>
              <a:ext uri="{FF2B5EF4-FFF2-40B4-BE49-F238E27FC236}">
                <a16:creationId xmlns:a16="http://schemas.microsoft.com/office/drawing/2014/main" id="{781AF6BE-D979-4676-9F6F-FBD6D781EF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>
            <a:extLst>
              <a:ext uri="{FF2B5EF4-FFF2-40B4-BE49-F238E27FC236}">
                <a16:creationId xmlns:a16="http://schemas.microsoft.com/office/drawing/2014/main" id="{588E91F4-3478-4B41-ADD2-9CA602D9D8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B76503-8976-4739-BE3F-46E53C45B6A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60531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3">
            <a:extLst>
              <a:ext uri="{FF2B5EF4-FFF2-40B4-BE49-F238E27FC236}">
                <a16:creationId xmlns:a16="http://schemas.microsoft.com/office/drawing/2014/main" id="{C655FBA1-5149-4287-9EBB-F2E8A7691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A4AD5D-2E41-4042-A263-E6833B832094}" type="datetimeFigureOut">
              <a:rPr lang="zh-CN" altLang="en-US"/>
              <a:pPr>
                <a:defRPr/>
              </a:pPr>
              <a:t>2018/12/8</a:t>
            </a:fld>
            <a:endParaRPr lang="zh-CN" altLang="en-US"/>
          </a:p>
        </p:txBody>
      </p:sp>
      <p:sp>
        <p:nvSpPr>
          <p:cNvPr id="8" name="页脚占位符 4">
            <a:extLst>
              <a:ext uri="{FF2B5EF4-FFF2-40B4-BE49-F238E27FC236}">
                <a16:creationId xmlns:a16="http://schemas.microsoft.com/office/drawing/2014/main" id="{40D9FD92-2D91-43FC-ACA1-935DEC4D3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灯片编号占位符 5">
            <a:extLst>
              <a:ext uri="{FF2B5EF4-FFF2-40B4-BE49-F238E27FC236}">
                <a16:creationId xmlns:a16="http://schemas.microsoft.com/office/drawing/2014/main" id="{164B4867-0B00-43D7-AC00-FE499A6972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F64645-A122-4838-A405-AE6A0087EC95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2385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3">
            <a:extLst>
              <a:ext uri="{FF2B5EF4-FFF2-40B4-BE49-F238E27FC236}">
                <a16:creationId xmlns:a16="http://schemas.microsoft.com/office/drawing/2014/main" id="{067E0862-5EF7-43C3-8676-101825A030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E69BD2-6449-4BC4-8753-307280F635CD}" type="datetimeFigureOut">
              <a:rPr lang="zh-CN" altLang="en-US"/>
              <a:pPr>
                <a:defRPr/>
              </a:pPr>
              <a:t>2018/12/8</a:t>
            </a:fld>
            <a:endParaRPr lang="zh-CN" altLang="en-US"/>
          </a:p>
        </p:txBody>
      </p:sp>
      <p:sp>
        <p:nvSpPr>
          <p:cNvPr id="4" name="页脚占位符 4">
            <a:extLst>
              <a:ext uri="{FF2B5EF4-FFF2-40B4-BE49-F238E27FC236}">
                <a16:creationId xmlns:a16="http://schemas.microsoft.com/office/drawing/2014/main" id="{58C7C8C9-D741-4D44-8A25-A19870EBCD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5">
            <a:extLst>
              <a:ext uri="{FF2B5EF4-FFF2-40B4-BE49-F238E27FC236}">
                <a16:creationId xmlns:a16="http://schemas.microsoft.com/office/drawing/2014/main" id="{E3A6E17E-724D-4B04-829F-CEF548626A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6BD94A-C561-48E9-864D-FE7B9BB686B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61199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>
            <a:extLst>
              <a:ext uri="{FF2B5EF4-FFF2-40B4-BE49-F238E27FC236}">
                <a16:creationId xmlns:a16="http://schemas.microsoft.com/office/drawing/2014/main" id="{8D83A326-DC68-4C57-94BF-2A276BA655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3CB4B8-8DCF-4242-B173-4C7E296CED0D}" type="datetimeFigureOut">
              <a:rPr lang="zh-CN" altLang="en-US"/>
              <a:pPr>
                <a:defRPr/>
              </a:pPr>
              <a:t>2018/12/8</a:t>
            </a:fld>
            <a:endParaRPr lang="zh-CN" altLang="en-US"/>
          </a:p>
        </p:txBody>
      </p:sp>
      <p:sp>
        <p:nvSpPr>
          <p:cNvPr id="3" name="页脚占位符 4">
            <a:extLst>
              <a:ext uri="{FF2B5EF4-FFF2-40B4-BE49-F238E27FC236}">
                <a16:creationId xmlns:a16="http://schemas.microsoft.com/office/drawing/2014/main" id="{ECDAD4B4-C389-46A7-8B32-B8D9596832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灯片编号占位符 5">
            <a:extLst>
              <a:ext uri="{FF2B5EF4-FFF2-40B4-BE49-F238E27FC236}">
                <a16:creationId xmlns:a16="http://schemas.microsoft.com/office/drawing/2014/main" id="{F45FCCD1-7ADD-4317-AA32-1DB26D47E4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F0B14D-9C2F-46F8-8573-42D79596458A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6048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3">
            <a:extLst>
              <a:ext uri="{FF2B5EF4-FFF2-40B4-BE49-F238E27FC236}">
                <a16:creationId xmlns:a16="http://schemas.microsoft.com/office/drawing/2014/main" id="{1DB6612E-5830-4456-A58A-B588F38DA3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B64FB6-F626-41D3-A827-956F9BF46BFD}" type="datetimeFigureOut">
              <a:rPr lang="zh-CN" altLang="en-US"/>
              <a:pPr>
                <a:defRPr/>
              </a:pPr>
              <a:t>2018/12/8</a:t>
            </a:fld>
            <a:endParaRPr lang="zh-CN" altLang="en-US"/>
          </a:p>
        </p:txBody>
      </p:sp>
      <p:sp>
        <p:nvSpPr>
          <p:cNvPr id="6" name="页脚占位符 4">
            <a:extLst>
              <a:ext uri="{FF2B5EF4-FFF2-40B4-BE49-F238E27FC236}">
                <a16:creationId xmlns:a16="http://schemas.microsoft.com/office/drawing/2014/main" id="{4392A898-A455-4BEB-A624-022C824089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>
            <a:extLst>
              <a:ext uri="{FF2B5EF4-FFF2-40B4-BE49-F238E27FC236}">
                <a16:creationId xmlns:a16="http://schemas.microsoft.com/office/drawing/2014/main" id="{89339A2D-60D0-49E0-BA1D-9FABC12966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9ED3CA-C753-4B64-A5B3-C67556A2611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0766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3">
            <a:extLst>
              <a:ext uri="{FF2B5EF4-FFF2-40B4-BE49-F238E27FC236}">
                <a16:creationId xmlns:a16="http://schemas.microsoft.com/office/drawing/2014/main" id="{6FCABADC-DF9E-4D21-858D-354FB2F91B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1B6C4E-34E8-41A9-BC10-E934FFBAECF8}" type="datetimeFigureOut">
              <a:rPr lang="zh-CN" altLang="en-US"/>
              <a:pPr>
                <a:defRPr/>
              </a:pPr>
              <a:t>2018/12/8</a:t>
            </a:fld>
            <a:endParaRPr lang="zh-CN" altLang="en-US"/>
          </a:p>
        </p:txBody>
      </p:sp>
      <p:sp>
        <p:nvSpPr>
          <p:cNvPr id="6" name="页脚占位符 4">
            <a:extLst>
              <a:ext uri="{FF2B5EF4-FFF2-40B4-BE49-F238E27FC236}">
                <a16:creationId xmlns:a16="http://schemas.microsoft.com/office/drawing/2014/main" id="{337CCF0D-7E61-4DEA-A593-A79BF3080F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>
            <a:extLst>
              <a:ext uri="{FF2B5EF4-FFF2-40B4-BE49-F238E27FC236}">
                <a16:creationId xmlns:a16="http://schemas.microsoft.com/office/drawing/2014/main" id="{22143635-90FA-48C1-8FAA-F9AD4BDB4B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6CC1DB-3CB5-4BF0-841F-3756D9193D3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94580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占位符 1">
            <a:extLst>
              <a:ext uri="{FF2B5EF4-FFF2-40B4-BE49-F238E27FC236}">
                <a16:creationId xmlns:a16="http://schemas.microsoft.com/office/drawing/2014/main" id="{A64E07E1-FB53-4F8B-8CD1-5943E6112248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文本占位符 2">
            <a:extLst>
              <a:ext uri="{FF2B5EF4-FFF2-40B4-BE49-F238E27FC236}">
                <a16:creationId xmlns:a16="http://schemas.microsoft.com/office/drawing/2014/main" id="{C8AB1C77-F284-46FB-84EE-D49FC4D500E1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9FB0DC1-FC48-4368-BAE7-0EA629ADC6F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675B0D6D-86D7-4348-922D-A8A7F0565D85}" type="datetimeFigureOut">
              <a:rPr lang="zh-CN" altLang="en-US"/>
              <a:pPr>
                <a:defRPr/>
              </a:pPr>
              <a:t>2018/12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60C6593-910C-4095-936C-9B56462DA9B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790DAD7-DD9A-4324-87E3-479B1AB3A9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0E13F9B3-F4F9-4BD4-BB35-839CE9E6C8D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  <a:ea typeface="宋体" charset="-122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  <a:ea typeface="宋体" charset="-122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  <a:ea typeface="宋体" charset="-122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  <a:ea typeface="宋体" charset="-122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  <a:ea typeface="宋体" charset="-122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  <a:ea typeface="宋体" charset="-122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  <a:ea typeface="宋体" charset="-122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  <a:ea typeface="宋体" charset="-122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image" Target="../media/image9.png"/><Relationship Id="rId4" Type="http://schemas.openxmlformats.org/officeDocument/2006/relationships/image" Target="../media/image3.jpeg"/><Relationship Id="rId9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5AE61B62-BE32-4048-A939-508F0BEF78C5}"/>
              </a:ext>
            </a:extLst>
          </p:cNvPr>
          <p:cNvSpPr txBox="1"/>
          <p:nvPr/>
        </p:nvSpPr>
        <p:spPr>
          <a:xfrm>
            <a:off x="565111" y="1725623"/>
            <a:ext cx="11528917" cy="29510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Figure. S1. Alignment of three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ntersweet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nts SQSs protein sequences. The black blocks are the locations of the different sites and the conserved domains was marked by the red underline.</a:t>
            </a:r>
          </a:p>
          <a:p>
            <a:pPr algn="just">
              <a:lnSpc>
                <a:spcPct val="150000"/>
              </a:lnSpc>
            </a:pP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dditional file 1: Figure. S2. The TMHMM  and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al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ediction result about the three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ntersweet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QSs </a:t>
            </a:r>
          </a:p>
          <a:p>
            <a:pPr algn="just">
              <a:lnSpc>
                <a:spcPct val="150000"/>
              </a:lnSpc>
            </a:pP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he SQS1 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 thalian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>
              <a:lnSpc>
                <a:spcPct val="150000"/>
              </a:lnSpc>
            </a:pP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Table S1. The compounds of dichloromethane extraction 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hejiangensis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liage.</a:t>
            </a:r>
          </a:p>
          <a:p>
            <a:pPr algn="just">
              <a:lnSpc>
                <a:spcPct val="150000"/>
              </a:lnSpc>
            </a:pP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Table S2. The volatiles compounds 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hejiangensis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liage by SPME. </a:t>
            </a:r>
          </a:p>
          <a:p>
            <a:pPr algn="just">
              <a:lnSpc>
                <a:spcPct val="150000"/>
              </a:lnSpc>
            </a:pP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Table S3. The accession number of SQSs sequences. </a:t>
            </a:r>
          </a:p>
        </p:txBody>
      </p:sp>
    </p:spTree>
    <p:extLst>
      <p:ext uri="{BB962C8B-B14F-4D97-AF65-F5344CB8AC3E}">
        <p14:creationId xmlns:p14="http://schemas.microsoft.com/office/powerpoint/2010/main" val="14278750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矩形 4">
            <a:extLst>
              <a:ext uri="{FF2B5EF4-FFF2-40B4-BE49-F238E27FC236}">
                <a16:creationId xmlns:a16="http://schemas.microsoft.com/office/drawing/2014/main" id="{10DF6582-2F1B-4EB2-A783-5A88B3809C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37199" y="142223"/>
            <a:ext cx="238760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just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Figure.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6FB8A38-0ADE-4567-B5F7-6EDD40A55C0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2278" y="522000"/>
            <a:ext cx="7867444" cy="633600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图片 3">
            <a:extLst>
              <a:ext uri="{FF2B5EF4-FFF2-40B4-BE49-F238E27FC236}">
                <a16:creationId xmlns:a16="http://schemas.microsoft.com/office/drawing/2014/main" id="{4140BE3F-E3D2-4D21-886D-6CD0798FAA8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2" t="37534" r="47234" b="15157"/>
          <a:stretch>
            <a:fillRect/>
          </a:stretch>
        </p:blipFill>
        <p:spPr bwMode="auto">
          <a:xfrm>
            <a:off x="2493962" y="883445"/>
            <a:ext cx="3289300" cy="1020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267" name="图片 4">
            <a:extLst>
              <a:ext uri="{FF2B5EF4-FFF2-40B4-BE49-F238E27FC236}">
                <a16:creationId xmlns:a16="http://schemas.microsoft.com/office/drawing/2014/main" id="{C715CD45-01AA-45DD-A9B0-FBF9BC95679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42" t="37794" r="46571" b="14175"/>
          <a:stretch>
            <a:fillRect/>
          </a:stretch>
        </p:blipFill>
        <p:spPr bwMode="auto">
          <a:xfrm>
            <a:off x="2502693" y="2197100"/>
            <a:ext cx="3289300" cy="101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268" name="文本框 5">
            <a:extLst>
              <a:ext uri="{FF2B5EF4-FFF2-40B4-BE49-F238E27FC236}">
                <a16:creationId xmlns:a16="http://schemas.microsoft.com/office/drawing/2014/main" id="{7D059866-93F5-4C5C-BEAD-6AC9E37388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0657" y="2007394"/>
            <a:ext cx="2720975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33751" tIns="16875" rIns="33751" bIns="16875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HMM posterior probabilities for </a:t>
            </a:r>
            <a:r>
              <a:rPr lang="en-US" altLang="zh-CN" sz="7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sSQS</a:t>
            </a:r>
            <a:endParaRPr lang="zh-CN" altLang="en-US" sz="7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69" name="文本框 6">
            <a:extLst>
              <a:ext uri="{FF2B5EF4-FFF2-40B4-BE49-F238E27FC236}">
                <a16:creationId xmlns:a16="http://schemas.microsoft.com/office/drawing/2014/main" id="{8BDE94AE-CF47-4CDB-9FFE-C76EEE82F7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88432" y="719932"/>
            <a:ext cx="2743200" cy="141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33751" tIns="16875" rIns="33751" bIns="16875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HMM posterior probabilities for </a:t>
            </a:r>
            <a:r>
              <a:rPr lang="en-US" altLang="zh-CN" sz="7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gSQS</a:t>
            </a:r>
            <a:endParaRPr lang="zh-CN" altLang="en-US" sz="7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270" name="图片 7">
            <a:extLst>
              <a:ext uri="{FF2B5EF4-FFF2-40B4-BE49-F238E27FC236}">
                <a16:creationId xmlns:a16="http://schemas.microsoft.com/office/drawing/2014/main" id="{CE2A754E-6BED-4A06-A3CE-128C1D2A857D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89" t="38586" r="47217" b="14703"/>
          <a:stretch>
            <a:fillRect/>
          </a:stretch>
        </p:blipFill>
        <p:spPr bwMode="auto">
          <a:xfrm>
            <a:off x="2561033" y="3624016"/>
            <a:ext cx="3172619" cy="10334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271" name="文本框 8">
            <a:extLst>
              <a:ext uri="{FF2B5EF4-FFF2-40B4-BE49-F238E27FC236}">
                <a16:creationId xmlns:a16="http://schemas.microsoft.com/office/drawing/2014/main" id="{8FF494FE-9B01-470E-BA07-E4AC628B6D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2075" y="3381374"/>
            <a:ext cx="2690812" cy="141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33751" tIns="16875" rIns="33751" bIns="16875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HMM posterior probabilities for </a:t>
            </a:r>
            <a:r>
              <a:rPr lang="en-US" altLang="zh-CN" sz="7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zSQS</a:t>
            </a:r>
            <a:endParaRPr lang="zh-CN" altLang="en-US" sz="7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72" name="文本框 11">
            <a:extLst>
              <a:ext uri="{FF2B5EF4-FFF2-40B4-BE49-F238E27FC236}">
                <a16:creationId xmlns:a16="http://schemas.microsoft.com/office/drawing/2014/main" id="{E8218E7C-C9F5-49CA-9FDC-C869AB4D5064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2215356" y="1130696"/>
            <a:ext cx="175883" cy="4699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square" lIns="33751" tIns="16875" rIns="33751" bIns="16875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700">
                <a:latin typeface="Times New Roman" panose="02020603050405020304" pitchFamily="18" charset="0"/>
                <a:cs typeface="Times New Roman" panose="02020603050405020304" pitchFamily="18" charset="0"/>
              </a:rPr>
              <a:t>probability</a:t>
            </a:r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73" name="文本框 12">
            <a:extLst>
              <a:ext uri="{FF2B5EF4-FFF2-40B4-BE49-F238E27FC236}">
                <a16:creationId xmlns:a16="http://schemas.microsoft.com/office/drawing/2014/main" id="{92E36E1B-CF85-423F-895A-C8502A0FB7ED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2215355" y="2487076"/>
            <a:ext cx="175883" cy="444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square" lIns="33751" tIns="16875" rIns="33751" bIns="16875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ability</a:t>
            </a:r>
            <a:endParaRPr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74" name="文本框 11">
            <a:extLst>
              <a:ext uri="{FF2B5EF4-FFF2-40B4-BE49-F238E27FC236}">
                <a16:creationId xmlns:a16="http://schemas.microsoft.com/office/drawing/2014/main" id="{8B1CBA9A-CFAA-4908-8E0D-2B7F5DD61B33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2215355" y="3851811"/>
            <a:ext cx="175883" cy="433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square" lIns="33751" tIns="16875" rIns="33751" bIns="16875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ability</a:t>
            </a:r>
            <a:endParaRPr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75" name="文本框 15">
            <a:extLst>
              <a:ext uri="{FF2B5EF4-FFF2-40B4-BE49-F238E27FC236}">
                <a16:creationId xmlns:a16="http://schemas.microsoft.com/office/drawing/2014/main" id="{7A358A15-9C0B-4601-A610-917B5B8097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739775" y="3349625"/>
            <a:ext cx="120650" cy="65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33751" tIns="16875" rIns="33751" bIns="16875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zh-CN" altLang="en-US" sz="200">
              <a:latin typeface="Arial" panose="020B0604020202020204" pitchFamily="34" charset="0"/>
            </a:endParaRPr>
          </a:p>
        </p:txBody>
      </p:sp>
      <p:pic>
        <p:nvPicPr>
          <p:cNvPr id="11276" name="图片 23">
            <a:extLst>
              <a:ext uri="{FF2B5EF4-FFF2-40B4-BE49-F238E27FC236}">
                <a16:creationId xmlns:a16="http://schemas.microsoft.com/office/drawing/2014/main" id="{FE5C5D18-72E4-4250-B57C-34C8D383A21B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83" t="43971" r="46309" b="7578"/>
          <a:stretch>
            <a:fillRect/>
          </a:stretch>
        </p:blipFill>
        <p:spPr bwMode="auto">
          <a:xfrm>
            <a:off x="2566193" y="4972595"/>
            <a:ext cx="3225800" cy="1020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277" name="矩形 1">
            <a:extLst>
              <a:ext uri="{FF2B5EF4-FFF2-40B4-BE49-F238E27FC236}">
                <a16:creationId xmlns:a16="http://schemas.microsoft.com/office/drawing/2014/main" id="{2452A830-7BD0-4841-B972-AA6DC98038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32150" y="4751388"/>
            <a:ext cx="1677988" cy="141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33751" tIns="16875" rIns="33751" bIns="16875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HMM posterior probabilities for </a:t>
            </a: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SQS1</a:t>
            </a:r>
            <a:endParaRPr lang="zh-CN" altLang="en-US" sz="7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78" name="文本框 11">
            <a:extLst>
              <a:ext uri="{FF2B5EF4-FFF2-40B4-BE49-F238E27FC236}">
                <a16:creationId xmlns:a16="http://schemas.microsoft.com/office/drawing/2014/main" id="{332E57A0-5CC6-473F-941D-213A8C8077EA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2215354" y="5123258"/>
            <a:ext cx="175883" cy="444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square" lIns="33751" tIns="16875" rIns="33751" bIns="16875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ability</a:t>
            </a:r>
            <a:endParaRPr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79" name="文本框 2">
            <a:extLst>
              <a:ext uri="{FF2B5EF4-FFF2-40B4-BE49-F238E27FC236}">
                <a16:creationId xmlns:a16="http://schemas.microsoft.com/office/drawing/2014/main" id="{6F93D4AF-8BE0-4F66-9D6C-7EF115BD7C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93107" y="6157664"/>
            <a:ext cx="717550" cy="1418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3751" tIns="16875" rIns="33751" bIns="16875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700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transmembrane</a:t>
            </a:r>
            <a:endParaRPr lang="zh-CN" altLang="en-US" sz="700" dirty="0">
              <a:latin typeface="Times New Roman" panose="02020603050405020304" pitchFamily="18" charset="0"/>
              <a:ea typeface="Meiryo UI" panose="020B0604030504040204" pitchFamily="34" charset="-128"/>
              <a:cs typeface="Times New Roman" panose="02020603050405020304" pitchFamily="18" charset="0"/>
            </a:endParaRP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E392B71D-59B0-4207-BE52-D476EF53706C}"/>
              </a:ext>
            </a:extLst>
          </p:cNvPr>
          <p:cNvCxnSpPr/>
          <p:nvPr/>
        </p:nvCxnSpPr>
        <p:spPr>
          <a:xfrm>
            <a:off x="2710657" y="6228555"/>
            <a:ext cx="592138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81" name="文本框 25">
            <a:extLst>
              <a:ext uri="{FF2B5EF4-FFF2-40B4-BE49-F238E27FC236}">
                <a16:creationId xmlns:a16="http://schemas.microsoft.com/office/drawing/2014/main" id="{20666A4E-3383-43D4-9696-641C32F313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63923" y="6157664"/>
            <a:ext cx="421481" cy="1417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3751" tIns="16875" rIns="33751" bIns="16875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side</a:t>
            </a:r>
            <a:endParaRPr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F590CB9E-A06A-4D8D-A057-F9A26DDD9AA8}"/>
              </a:ext>
            </a:extLst>
          </p:cNvPr>
          <p:cNvCxnSpPr/>
          <p:nvPr/>
        </p:nvCxnSpPr>
        <p:spPr>
          <a:xfrm>
            <a:off x="3863576" y="6228556"/>
            <a:ext cx="592137" cy="0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83" name="文本框 26">
            <a:extLst>
              <a:ext uri="{FF2B5EF4-FFF2-40B4-BE49-F238E27FC236}">
                <a16:creationId xmlns:a16="http://schemas.microsoft.com/office/drawing/2014/main" id="{0B743E15-A42C-4155-8AB6-2E0CEF282D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58519" y="6143624"/>
            <a:ext cx="560388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33751" tIns="16875" rIns="33751" bIns="16875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700">
                <a:latin typeface="Times New Roman" panose="02020603050405020304" pitchFamily="18" charset="0"/>
                <a:cs typeface="Times New Roman" panose="02020603050405020304" pitchFamily="18" charset="0"/>
              </a:rPr>
              <a:t>outside</a:t>
            </a:r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52E0DEEF-1B85-473C-B0A5-EBC04FEABA5B}"/>
              </a:ext>
            </a:extLst>
          </p:cNvPr>
          <p:cNvCxnSpPr/>
          <p:nvPr/>
        </p:nvCxnSpPr>
        <p:spPr>
          <a:xfrm>
            <a:off x="5087936" y="6215061"/>
            <a:ext cx="592138" cy="0"/>
          </a:xfrm>
          <a:prstGeom prst="line">
            <a:avLst/>
          </a:prstGeom>
          <a:ln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85" name="文本框 16">
            <a:extLst>
              <a:ext uri="{FF2B5EF4-FFF2-40B4-BE49-F238E27FC236}">
                <a16:creationId xmlns:a16="http://schemas.microsoft.com/office/drawing/2014/main" id="{D9E8B200-7B3D-44DA-811F-15C857D922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18907" y="276065"/>
            <a:ext cx="2667793" cy="2495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3751" tIns="16875" rIns="33751" bIns="16875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Figure.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zh-CN" alt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286" name="图片 9">
            <a:extLst>
              <a:ext uri="{FF2B5EF4-FFF2-40B4-BE49-F238E27FC236}">
                <a16:creationId xmlns:a16="http://schemas.microsoft.com/office/drawing/2014/main" id="{426DB5CC-545B-417F-99A9-FFB524783147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69"/>
          <a:stretch>
            <a:fillRect/>
          </a:stretch>
        </p:blipFill>
        <p:spPr bwMode="auto">
          <a:xfrm>
            <a:off x="5981700" y="904875"/>
            <a:ext cx="2873375" cy="1068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287" name="文本框 27">
            <a:extLst>
              <a:ext uri="{FF2B5EF4-FFF2-40B4-BE49-F238E27FC236}">
                <a16:creationId xmlns:a16="http://schemas.microsoft.com/office/drawing/2014/main" id="{E007B5FA-D041-499E-847C-0BD2637CC2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81700" y="705644"/>
            <a:ext cx="2974975" cy="141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33751" tIns="16875" rIns="33751" bIns="16875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alp-4.1 prediction (</a:t>
            </a:r>
            <a:r>
              <a:rPr lang="en-US" altLang="zh-CN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uk</a:t>
            </a: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etworks): </a:t>
            </a:r>
            <a:r>
              <a:rPr lang="en-US" altLang="zh-CN" sz="7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gSQS</a:t>
            </a:r>
            <a:endParaRPr lang="zh-CN" altLang="en-US" sz="7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288" name="图片 10">
            <a:extLst>
              <a:ext uri="{FF2B5EF4-FFF2-40B4-BE49-F238E27FC236}">
                <a16:creationId xmlns:a16="http://schemas.microsoft.com/office/drawing/2014/main" id="{124AA937-4086-4CC3-A79E-0E0EEDE70DCA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948"/>
          <a:stretch>
            <a:fillRect/>
          </a:stretch>
        </p:blipFill>
        <p:spPr bwMode="auto">
          <a:xfrm>
            <a:off x="5930899" y="2197100"/>
            <a:ext cx="2974975" cy="1066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289" name="文本框 28">
            <a:extLst>
              <a:ext uri="{FF2B5EF4-FFF2-40B4-BE49-F238E27FC236}">
                <a16:creationId xmlns:a16="http://schemas.microsoft.com/office/drawing/2014/main" id="{95F24374-908B-4B98-B7B9-F595D8C4CC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80100" y="2031207"/>
            <a:ext cx="2974975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33751" tIns="16875" rIns="33751" bIns="16875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alp-4.1 prediction (</a:t>
            </a:r>
            <a:r>
              <a:rPr lang="en-US" altLang="zh-CN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uk</a:t>
            </a: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etworks): </a:t>
            </a:r>
            <a:r>
              <a:rPr lang="en-US" altLang="zh-CN" sz="7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sSQS</a:t>
            </a:r>
            <a:endParaRPr lang="zh-CN" altLang="en-US" sz="7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290" name="图片 14">
            <a:extLst>
              <a:ext uri="{FF2B5EF4-FFF2-40B4-BE49-F238E27FC236}">
                <a16:creationId xmlns:a16="http://schemas.microsoft.com/office/drawing/2014/main" id="{312D204E-D3EE-4963-AD7E-23D7FC49E3DF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791"/>
          <a:stretch>
            <a:fillRect/>
          </a:stretch>
        </p:blipFill>
        <p:spPr bwMode="auto">
          <a:xfrm>
            <a:off x="5930899" y="3612356"/>
            <a:ext cx="2974975" cy="1066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291" name="文本框 29">
            <a:extLst>
              <a:ext uri="{FF2B5EF4-FFF2-40B4-BE49-F238E27FC236}">
                <a16:creationId xmlns:a16="http://schemas.microsoft.com/office/drawing/2014/main" id="{B20D5B7B-058C-47D5-AC27-8953C124D6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30899" y="3389313"/>
            <a:ext cx="2974975" cy="141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33751" tIns="16875" rIns="33751" bIns="16875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alp-4.1 prediction (</a:t>
            </a:r>
            <a:r>
              <a:rPr lang="en-US" altLang="zh-CN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uk</a:t>
            </a: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etworks): </a:t>
            </a:r>
            <a:r>
              <a:rPr lang="en-US" altLang="zh-CN" sz="7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zSQS</a:t>
            </a:r>
            <a:endParaRPr lang="zh-CN" altLang="en-US" sz="7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292" name="图片 17">
            <a:extLst>
              <a:ext uri="{FF2B5EF4-FFF2-40B4-BE49-F238E27FC236}">
                <a16:creationId xmlns:a16="http://schemas.microsoft.com/office/drawing/2014/main" id="{6350E716-FAB4-4FF4-9FE4-52E5041CA3C4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932"/>
          <a:stretch>
            <a:fillRect/>
          </a:stretch>
        </p:blipFill>
        <p:spPr bwMode="auto">
          <a:xfrm>
            <a:off x="5903119" y="5000227"/>
            <a:ext cx="3038475" cy="1066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293" name="文本框 30">
            <a:extLst>
              <a:ext uri="{FF2B5EF4-FFF2-40B4-BE49-F238E27FC236}">
                <a16:creationId xmlns:a16="http://schemas.microsoft.com/office/drawing/2014/main" id="{2DE0BC6D-92A2-4BAA-B6FD-835A942E21C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35660" y="4796632"/>
            <a:ext cx="2974975" cy="141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33751" tIns="16875" rIns="33751" bIns="16875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700">
                <a:latin typeface="Times New Roman" panose="02020603050405020304" pitchFamily="18" charset="0"/>
                <a:cs typeface="Times New Roman" panose="02020603050405020304" pitchFamily="18" charset="0"/>
              </a:rPr>
              <a:t>Signalp-4.1 prediction (euk networks): </a:t>
            </a:r>
            <a:r>
              <a:rPr lang="en-US" altLang="zh-CN" sz="700" i="1">
                <a:latin typeface="Times New Roman" panose="02020603050405020304" pitchFamily="18" charset="0"/>
                <a:cs typeface="Times New Roman" panose="02020603050405020304" pitchFamily="18" charset="0"/>
              </a:rPr>
              <a:t>AtSQS1</a:t>
            </a:r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文本框 16">
            <a:extLst>
              <a:ext uri="{FF2B5EF4-FFF2-40B4-BE49-F238E27FC236}">
                <a16:creationId xmlns:a16="http://schemas.microsoft.com/office/drawing/2014/main" id="{311FC3A3-DCF9-43C8-B423-96FEC22183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9120" y="107793"/>
            <a:ext cx="2437880" cy="2495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3751" tIns="16875" rIns="33751" bIns="16875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Table S1. 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A6424F2C-1151-4A29-84B1-4DF7B4857C7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26967328"/>
              </p:ext>
            </p:extLst>
          </p:nvPr>
        </p:nvGraphicFramePr>
        <p:xfrm>
          <a:off x="2047875" y="357316"/>
          <a:ext cx="7927976" cy="6697791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368548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4590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2239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7419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141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me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st Dimension Time (minutes)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nd Dimension Time (s)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ea 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-Hexenal, (E)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3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1808524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-Hexen-1-ol, (E)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16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59249445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yr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416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84356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nzene, 1,1'-(1,2-cyclobutanediyl)bis-, cis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97456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l-GR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-)-β-</a:t>
                      </a:r>
                      <a:r>
                        <a:rPr lang="en-US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nene*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166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4887529</a:t>
                      </a:r>
                      <a:endParaRPr lang="en-US" altLang="zh-CN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cyclo[3.1.0]hex-2-ene, 4-methyl-1-(1-methylethyl)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33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5310690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xime-, methoxy-phenyl-_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416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42884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+)-2-Car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398437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ns-</a:t>
                      </a:r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-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im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58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04136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R)-2,6,6-Trimethylbicyclo[3.1.1]hept-2-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58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96787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cyclo[3.1.0]hex-2-ene, 2-methyl-5-(1-methylethyl)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7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636959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mph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916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1319480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clopentene, 3-isopropenyl-5, 5-dimethy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764496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3-Dehydro-1,8-cineol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83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2899147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ç-Terpin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16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393323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ucalypt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41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53533126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hydrocarvyl acetat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58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066259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á-Myrc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91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78198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nzaldehyde, 3-methyl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418840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monene oxide, trans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08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540070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nalool*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08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44574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opuleg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41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0978292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727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+)-2-Bornano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8125708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-2,7,7-trimethylbicyclo[2.2.1]heptan-2-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91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607054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rpine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66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8562706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-Undecen-3-yne, (E)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8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949500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tronellal*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8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82402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nocarvo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8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010233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-Oxabicyclo[2.2.2]octan-6-one, 1,3,3-trimethyl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16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4957265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tronell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2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9820580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5,5-Trimethyl-6-methylene-cyclohex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3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418982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cyclo[3.3.0]octan-3-one, 7-ethylidene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3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296536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S)-(-)-Citronellic acid, methyl ester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41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004928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dol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91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50792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nocarvo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08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26524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à-Cubeb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2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8887715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lcarin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3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157748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pa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08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487136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-)-á-Bourbon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08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00641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H-Cycloprop[e]azulene, 1a,2,3,4,4a,5,6,7b-octahydro-1,1,4,7-tetramethyl-, [1aR-(1a?4?4a?7b?]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3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937384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à-Guai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91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346421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yophyllene*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91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154104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mul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2388338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γ-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lang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2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962594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rmacrene D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3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159474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oled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937384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s-á-Farnes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7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272227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s-Muurola-4(15),5-di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7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79649440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48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-Isopropyl-4,7-dimethyl-1,2,3,5,6,8a-hexahydronaphthal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08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680891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49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ns-Sesquisabinene hydrat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66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14241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50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ç-Elem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66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778158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51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à-Calacor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66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35618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52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tyric acid, 3-methyl-3-[2-isopropylphenyl]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66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543107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53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à-Muurol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7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144511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54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tivene　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7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5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45162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55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-)-Spathulen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8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935791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56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oaromadendrene oxide-(1)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08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705585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57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-epi-cis-sesquisabinene hydrat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16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375810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58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d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3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0090879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59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à-Corocal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41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982730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60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R,7S,E)-7-Isopropyl-4,10-dimethylenecyclodec-5-en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66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765271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61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,Z,Z-1,4,6,9-Nonadecatetra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8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31323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62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olongifolen-5-o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8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311919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63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à-Cadin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91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640867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64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ns-Farnes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91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041602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65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H-Cycloprop[e]azulene, 1a,2,3,4,4a,5,6,7b-octahydro-1,1,4,7-tetramethyl-, [1aR-(1aà,4à,4aá,7bà)]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91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89137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66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4-Dimethylstyr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08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592600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67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yophyllene oxid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3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010708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68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dene oxide-(II)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3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72857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69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rnesene epoxide, E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41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8795564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70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 4-Methanoazulen-9-one, decahydro-1, 5, 5, 8</a:t>
                      </a:r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-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tramethy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41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977389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71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 5, 9-Undecatriene, 2, 6, 10-trimethyl-, (Z)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4214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72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-(3-Methyl-cyclopent-2-enyl)-cyclohex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5360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73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rolan-3,9(11)-diene-10-peroxy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031063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74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H-Indole, 2-methyl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66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92919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75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ospathulen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66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63195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76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cloheptane, 4-methylene-1-methyl-2-(2-methyl-1-propen-1-yl)-1-viny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7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01365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77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á-Sitoster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078624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78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ptomeridi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41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8441920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79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à-D-Glucopyranoside, methy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8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45124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80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á-Eudesmol, TMS derivativ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8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67921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81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ringenin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8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63714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82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u.-Muurol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8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0937705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83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igmaster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41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702502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84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ns-Ferulic acid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3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15931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85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icylic acid, 2TMS derivativ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66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519620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86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clohexane, 1-methylene-4-(1-methylethenyl)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08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8178767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87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á-Myrc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08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78198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88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monene*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41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969777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89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dol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2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50792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90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oaromadendr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044072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91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à-Cadin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3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640867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92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-)-Spathulen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16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216822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93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opoletin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3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17713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94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-Borne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66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0563603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95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udesma-4(15),7-dien-1á -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66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784199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96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lycanthidi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66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11828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97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onanthi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7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959684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98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yptami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8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90081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099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qualene*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684086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100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umarin, 6-benzyloxy-3,4-dihydro-4,4-dimethyl-7-nitro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87140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101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-)-Aristol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.83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8177209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/>
                </a:tc>
                <a:extLst>
                  <a:ext uri="{0D108BD9-81ED-4DB2-BD59-A6C34878D82A}">
                    <a16:rowId xmlns:a16="http://schemas.microsoft.com/office/drawing/2014/main" val="10102"/>
                  </a:ext>
                </a:extLst>
              </a:tr>
              <a:tr h="60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á Carotene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.8333</a:t>
                      </a:r>
                      <a:endParaRPr lang="en-US" altLang="zh-CN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55</a:t>
                      </a:r>
                      <a:endParaRPr lang="en-US" altLang="zh-CN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399173</a:t>
                      </a:r>
                      <a:endParaRPr lang="en-US" altLang="zh-CN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892" marR="1892" marT="189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03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文本框 16">
            <a:extLst>
              <a:ext uri="{FF2B5EF4-FFF2-40B4-BE49-F238E27FC236}">
                <a16:creationId xmlns:a16="http://schemas.microsoft.com/office/drawing/2014/main" id="{406B257C-ADD0-4306-831E-AF962FCA05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24561" y="136635"/>
            <a:ext cx="1993839" cy="2495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3751" tIns="16875" rIns="33751" bIns="16875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Table S2.</a:t>
            </a:r>
            <a:endParaRPr lang="zh-CN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D15FFFC8-30B1-4E5C-800C-41A91985764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17227965"/>
              </p:ext>
            </p:extLst>
          </p:nvPr>
        </p:nvGraphicFramePr>
        <p:xfrm>
          <a:off x="2008981" y="508020"/>
          <a:ext cx="8174038" cy="634998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35986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54873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6543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tention Time(minutes)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ounds Name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ea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3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-Pentenal, 2-methyl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349703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-Hexenal, (E)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273190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7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-Hexen-1-ol, (E)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37598177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61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yr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4716804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73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icyclo[3.1.0]hex-2-ene, 4-methyl-1-(1-methylethyl)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8455986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98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1R)-2,6,6-Trimethylbicyclo[3.1.1]hept-2-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8185517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33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-(2-Methylphenyl)ethan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491259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93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nzaldehyd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267594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12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xime-, methoxy-phenyl-_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1816065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25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binen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1307774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31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-)-β-</a:t>
                      </a:r>
                      <a:r>
                        <a:rPr lang="en-US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nene*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4513075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50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-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hylstyr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948559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86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rc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54383761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10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ucalypt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92121333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8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im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8603593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05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γ-</a:t>
                      </a:r>
                      <a:r>
                        <a:rPr lang="en-US" sz="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rpinene</a:t>
                      </a:r>
                      <a:r>
                        <a:rPr lang="en-US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1586224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32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ns-4-Thujan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9388915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91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rpinolen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679729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31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Linalool*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88277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4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monene oxide, trans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48234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52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5,5-Trimethyl-6-methylene-cyclohex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616624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58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+)-2-Bornano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033413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66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opuleg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36211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98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R)-(+)-Citronellal*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2374047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16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inocarvo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560279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50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-Undecen-3-yne, (E)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703017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61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-)-Terpinen-4-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8138789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16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-</a:t>
                      </a:r>
                      <a:r>
                        <a:rPr lang="en-US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rpineol*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96432670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47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icyclo[3.3.0]octan-3-one, 7-ethylidene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825802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60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6-Methyl-cyclodec-5-en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94298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69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2-Oxabicyclo[2.2.2]octan-6-one, 1,3,3-trimethyl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299475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96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-2-Hydroxycineol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367479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1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tronell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7594378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90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,Z,Z-1,4,6,9-Nonadecatetra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353794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02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S)-(-)-Citronellic acid, methyl ester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140879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36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-(3-Methyl-cyclopent-2-enyl)-cyclohex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992162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15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dol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131613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86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-epi-cis-sesquisabinene hydrate*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575371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07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clohexane, 1-ethenyl-1-methyl-2-(1-methylethenyl)-4-(1-methylethylidene)-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9947913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40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-</a:t>
                      </a:r>
                      <a:r>
                        <a:rPr lang="en-US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bebene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807946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54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Ledene oxide-(II)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55401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71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lcarin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109511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98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Ylang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672225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15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-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pa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1931069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34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-)-β-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ourbon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8787162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47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s-</a:t>
                      </a:r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pa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712437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53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-)-β-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lem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735336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99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-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urjun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6710497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48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31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yophyllene*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7513914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49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6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H-Cyclopropa[a]naphthalene, 1a,2,3,5,6,7,7a,7b-octahydro-1,1,7,7a-tetramethyl-, [1aR-(1a</a:t>
                      </a:r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,7α,7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,7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)]-</a:t>
                      </a:r>
                      <a:endParaRPr lang="el-GR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319515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50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72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-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uai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0114898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51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85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emophil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11516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52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92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dina-3,5-di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093985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53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13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4,7,-Cycloundecatriene, 1,5,9,9-tetramethyl-, Z,Z,Z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100140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54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28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oaromadendr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1910035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55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34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s-Muurola-4(15),5-di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7295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56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65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-)-β-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din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224243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57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rmacrene D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113000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58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97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udesm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94347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59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02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ngifolene-(V4)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753223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60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14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γ-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urol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5176944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61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21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clogermacra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4492684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62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26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-</a:t>
                      </a:r>
                      <a:r>
                        <a:rPr lang="en-US" sz="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urolene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2690982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63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41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δ-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uai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5760670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64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61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γ-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din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1168944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65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94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dina-1(10),4-di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7502490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66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.14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phthalene, 1,2,3,4,4a,7-hexahydro-1,6-dimethyl-4-(1-methylethyl)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054518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67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.34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-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lacor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234817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68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.49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nzene, 1,1'-(1-methyl-1,2-ethanediyl)bis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041506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69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.66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rmacra-1(10),4,7(11)-tri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165632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70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.78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lacor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119872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71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07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rmacrene D-4-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814839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72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58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rolan-3,9(11)-diene-10-peroxy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57705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73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72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d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38787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74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861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achidonic acid methyl ester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997015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75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043</a:t>
                      </a:r>
                      <a:endParaRPr lang="en-US" altLang="zh-CN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nzene, 1,1'-(1-butene-1,4-diyl)bis-, (Z)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6888514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76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13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α-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ocalene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495067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77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25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rolan-3,9(11)-diene-10-peroxy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693602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78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485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enzene, 1,1'-(3-methylbutylidene)bis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131249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79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56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-epi-</a:t>
                      </a:r>
                      <a:r>
                        <a:rPr lang="el-GR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-</a:t>
                      </a:r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dino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3198408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80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697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nzene, 1,1'-[1-(2-propenyl)-1,2-ethanediyl]bis-</a:t>
                      </a:r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9789072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81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234</a:t>
                      </a:r>
                      <a:endParaRPr lang="en-US" altLang="zh-CN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phthalene, 1,2,3,4-tetrahydro-2-phenyl-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7246749</a:t>
                      </a:r>
                      <a:endParaRPr lang="en-US" altLang="zh-CN" sz="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/>
                </a:tc>
                <a:extLst>
                  <a:ext uri="{0D108BD9-81ED-4DB2-BD59-A6C34878D82A}">
                    <a16:rowId xmlns:a16="http://schemas.microsoft.com/office/drawing/2014/main" val="10082"/>
                  </a:ext>
                </a:extLst>
              </a:tr>
              <a:tr h="7559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.513</a:t>
                      </a:r>
                      <a:endParaRPr lang="en-US" altLang="zh-CN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cubebol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6838237</a:t>
                      </a:r>
                      <a:endParaRPr lang="en-US" altLang="zh-CN" sz="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516" marR="2516" marT="251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83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D6C9A425-03BD-49E4-AC9B-889FC703798E}"/>
              </a:ext>
            </a:extLst>
          </p:cNvPr>
          <p:cNvGraphicFramePr>
            <a:graphicFrameLocks noGrp="1"/>
          </p:cNvGraphicFramePr>
          <p:nvPr/>
        </p:nvGraphicFramePr>
        <p:xfrm>
          <a:off x="4039338" y="628003"/>
          <a:ext cx="4500980" cy="596106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0270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00600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9226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929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breviatio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ession Numbe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ganis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29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K48128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gnolia officinalis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578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k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N69082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ospyros kaki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29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g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M71227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raitia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svenori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578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VA20399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cleaya cordat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578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B05603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mellia oleifer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2578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v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81937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ti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nifer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929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l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FZ93644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uphorbia lathyris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578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V88718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nax ginseng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29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uSQ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S66749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cyrrhiza uralensis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2578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d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S78117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us domestic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929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P_002313765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tula platyphyll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929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pSQ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KR76253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tula platyphyll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2578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V58897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ntella asiatic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929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g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P_010066209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ucalyptus grandis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929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g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D54645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uguiera gymnorhiz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2578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A66327.1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igella sativ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929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e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G66304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lygala tenuifoli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929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_195190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abidopsis thalian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929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O43006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nostemma pentaphyllum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929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V62379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phalotus follicularis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929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G29294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ussurea involucrat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929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IS98890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icotiana attenuat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929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r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P_006841632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borella trichopod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929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w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R60779.1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pterygium wilfordii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929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P_002313765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pulus trichocarp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929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b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|Q9SDW9|BSS_BOTB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otryococcus braunii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2578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lSQ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|P78589|FDFT_CANAX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dida albicans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929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DD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|B3Y522|DCD_DRY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ryopteris crassirhizom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929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mSQ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IL25719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laginella moellendorffii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929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SQ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K48128.1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gnolia officinali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943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SQ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H277637</a:t>
                      </a: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onanthus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ammalu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.C. Liu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943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SQ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H277638</a:t>
                      </a:r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onanthus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icifoliu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. Y. Hu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/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943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zSQ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H277639 </a:t>
                      </a:r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onanthus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hejiangensi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.C.Liu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867" marR="3867" marT="386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</a:tbl>
          </a:graphicData>
        </a:graphic>
      </p:graphicFrame>
      <p:sp>
        <p:nvSpPr>
          <p:cNvPr id="13420" name="文本框 16">
            <a:extLst>
              <a:ext uri="{FF2B5EF4-FFF2-40B4-BE49-F238E27FC236}">
                <a16:creationId xmlns:a16="http://schemas.microsoft.com/office/drawing/2014/main" id="{213619AA-838B-4FE2-B761-7AB886C9F6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23447" y="268931"/>
            <a:ext cx="2158453" cy="2495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3751" tIns="16875" rIns="33751" bIns="16875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Table S3. </a:t>
            </a:r>
            <a:endParaRPr lang="zh-CN" alt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60</TotalTime>
  <Words>1549</Words>
  <Application>Microsoft Office PowerPoint</Application>
  <PresentationFormat>宽屏</PresentationFormat>
  <Paragraphs>799</Paragraphs>
  <Slides>6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Chi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uanhua Liu</dc:creator>
  <cp:lastModifiedBy>Liu Guanhua</cp:lastModifiedBy>
  <cp:revision>85</cp:revision>
  <dcterms:created xsi:type="dcterms:W3CDTF">2018-05-03T00:20:34Z</dcterms:created>
  <dcterms:modified xsi:type="dcterms:W3CDTF">2018-12-08T14:00:10Z</dcterms:modified>
</cp:coreProperties>
</file>